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8CF3BEF-063F-5743-B9C3-E045CE642AE2}" name="McCutcheon, Kelley R" initials="KM" userId="S::kmccutch@fredhutch.org::af0c7d94-456b-49c5-ad8a-77833a1b65c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33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2868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5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968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943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930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221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1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123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134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454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643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400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E73B3-2A86-4721-83F5-53F1B4041D8B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F15452-19E8-4D43-9046-7BF6C16C0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06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BEC44A2-B930-95C9-9890-E2307FCC625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67" t="16740" r="7629" b="25778"/>
          <a:stretch/>
        </p:blipFill>
        <p:spPr bwMode="auto">
          <a:xfrm>
            <a:off x="3429000" y="149382"/>
            <a:ext cx="3360766" cy="23079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C183466-E3C1-D6BB-D6FE-D827E57CEF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1505209"/>
              </p:ext>
            </p:extLst>
          </p:nvPr>
        </p:nvGraphicFramePr>
        <p:xfrm>
          <a:off x="171171" y="884455"/>
          <a:ext cx="3048000" cy="73152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00285027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60069553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6985130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9241249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711416401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Epithelia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Tumo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troma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Immu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6707241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INPP4B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3.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4.7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9.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7.1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418524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TE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7.0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0.9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5.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.0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37722084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7.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7.3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0.2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3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75068718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AC8C842-547A-43D3-BF1C-FA37655DE373}"/>
              </a:ext>
            </a:extLst>
          </p:cNvPr>
          <p:cNvSpPr txBox="1"/>
          <p:nvPr/>
        </p:nvSpPr>
        <p:spPr>
          <a:xfrm>
            <a:off x="7950" y="10883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6E4510E-3948-C4A7-A205-CC9BC374B603}"/>
              </a:ext>
            </a:extLst>
          </p:cNvPr>
          <p:cNvSpPr txBox="1"/>
          <p:nvPr/>
        </p:nvSpPr>
        <p:spPr>
          <a:xfrm>
            <a:off x="131668" y="31625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E80B75F-5D55-4A44-6A73-732329FEBB1E}"/>
              </a:ext>
            </a:extLst>
          </p:cNvPr>
          <p:cNvSpPr txBox="1"/>
          <p:nvPr/>
        </p:nvSpPr>
        <p:spPr>
          <a:xfrm>
            <a:off x="3429000" y="28788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9F0841C-484C-CD0A-F8A3-270FD3638DF2}"/>
              </a:ext>
            </a:extLst>
          </p:cNvPr>
          <p:cNvSpPr txBox="1"/>
          <p:nvPr/>
        </p:nvSpPr>
        <p:spPr>
          <a:xfrm>
            <a:off x="4051240" y="2457306"/>
            <a:ext cx="21162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SE120716 epithelial cel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CBFA740-504D-DBC6-7744-4ECE543FF4DB}"/>
              </a:ext>
            </a:extLst>
          </p:cNvPr>
          <p:cNvSpPr txBox="1"/>
          <p:nvPr/>
        </p:nvSpPr>
        <p:spPr>
          <a:xfrm>
            <a:off x="401294" y="3110638"/>
            <a:ext cx="5977666" cy="146136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Supplemental Figure 1. </a:t>
            </a:r>
            <a:r>
              <a:rPr lang="en-US" sz="1200" b="1" dirty="0" err="1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Coexpression</a:t>
            </a:r>
            <a:r>
              <a:rPr lang="en-US" sz="1200" b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analysis of </a:t>
            </a:r>
            <a:r>
              <a:rPr lang="en-US" sz="1200" b="1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EZH2, INPP4B</a:t>
            </a:r>
            <a:r>
              <a:rPr lang="en-US" sz="1200" b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, and </a:t>
            </a:r>
            <a:r>
              <a:rPr lang="en-US" sz="1200" b="1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PTEN</a:t>
            </a:r>
            <a:r>
              <a:rPr lang="en-US" sz="1200" b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in normal prostate and prostate cancer.</a:t>
            </a:r>
            <a:r>
              <a:rPr lang="en-US" sz="1200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(a) </a:t>
            </a:r>
            <a:r>
              <a:rPr lang="en-US" sz="1200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EZH2</a:t>
            </a:r>
            <a:r>
              <a:rPr lang="en-US" sz="1200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-positive cells from epithelial, stromal, immune, and tumor cells from GSE181294were analyzed for </a:t>
            </a:r>
            <a:r>
              <a:rPr lang="en-US" sz="1200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EZH2, INPP4B</a:t>
            </a:r>
            <a:r>
              <a:rPr lang="en-US" sz="1200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, </a:t>
            </a:r>
            <a:r>
              <a:rPr lang="en-US" sz="1200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PTEN,</a:t>
            </a:r>
            <a:r>
              <a:rPr lang="en-US" sz="1200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and </a:t>
            </a:r>
            <a:r>
              <a:rPr lang="en-US" sz="1200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AR</a:t>
            </a:r>
            <a:r>
              <a:rPr lang="en-US" sz="1200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expression. Percents of </a:t>
            </a:r>
            <a:r>
              <a:rPr lang="en-US" sz="1200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EZH2</a:t>
            </a:r>
            <a:r>
              <a:rPr lang="en-US" sz="1200" i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positive cells expressing corresponding genes in indicated cell types are shown in the table. (b) Public dataset GSE120716 was used to determine </a:t>
            </a:r>
            <a:r>
              <a:rPr lang="en-US" sz="1200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INPP4B</a:t>
            </a:r>
            <a:r>
              <a:rPr lang="en-US" sz="1200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or </a:t>
            </a:r>
            <a:r>
              <a:rPr lang="en-US" sz="1200" i="1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PTEN</a:t>
            </a:r>
            <a:r>
              <a:rPr lang="en-US" sz="1200" dirty="0">
                <a:effectLst/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expression in all epithelial cells. The numbers of cells expressing each gene individually or in combination are shown.</a:t>
            </a:r>
          </a:p>
        </p:txBody>
      </p:sp>
    </p:spTree>
    <p:extLst>
      <p:ext uri="{BB962C8B-B14F-4D97-AF65-F5344CB8AC3E}">
        <p14:creationId xmlns:p14="http://schemas.microsoft.com/office/powerpoint/2010/main" val="271029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82</TotalTime>
  <Words>138</Words>
  <Application>Microsoft Office PowerPoint</Application>
  <PresentationFormat>Letter Paper (8.5x11 in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ina Agoulnik</dc:creator>
  <cp:lastModifiedBy>MDPI</cp:lastModifiedBy>
  <cp:revision>9</cp:revision>
  <dcterms:created xsi:type="dcterms:W3CDTF">2023-04-28T23:30:09Z</dcterms:created>
  <dcterms:modified xsi:type="dcterms:W3CDTF">2023-11-15T05:57:32Z</dcterms:modified>
</cp:coreProperties>
</file>